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1" r:id="rId2"/>
    <p:sldId id="281" r:id="rId3"/>
    <p:sldId id="282" r:id="rId4"/>
    <p:sldId id="283" r:id="rId5"/>
    <p:sldId id="284" r:id="rId6"/>
    <p:sldId id="276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62A0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1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6B6268-5845-4E46-ACA3-6A28A4E7A66E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FB090D-4C46-4934-92AE-E6000BAB65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1037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AF52-B752-A743-8A84-F372221B092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0092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AF52-B752-A743-8A84-F372221B092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5443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AF52-B752-A743-8A84-F372221B092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91991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AF52-B752-A743-8A84-F372221B092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30690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AF52-B752-A743-8A84-F372221B092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25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8764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739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671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078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83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28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6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043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657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305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2067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20C4A-B385-4BFB-9FF4-050DC7CD8E95}" type="datetimeFigureOut">
              <a:rPr lang="en-US" smtClean="0"/>
              <a:t>6/23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7E8705-8424-4C59-AB12-D1FE391B03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3855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8C6C265-C6EE-4518-8311-1F64206895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3694" y="1441186"/>
            <a:ext cx="1844026" cy="17236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B0CCA5C-E71A-4C79-81DB-1961647050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3848" y="1441186"/>
            <a:ext cx="1840263" cy="17236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64DA644-5F73-4CC2-B5D2-2B51F226BA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3694" y="4557191"/>
            <a:ext cx="1911219" cy="1720859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97A2B6C-CA19-4C7B-B36B-2E921EA0395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26996" y="4560377"/>
            <a:ext cx="1918833" cy="1717051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989615C8-193B-4743-A9AE-C51285BD8D09}"/>
              </a:ext>
            </a:extLst>
          </p:cNvPr>
          <p:cNvSpPr/>
          <p:nvPr/>
        </p:nvSpPr>
        <p:spPr>
          <a:xfrm>
            <a:off x="158944" y="5205612"/>
            <a:ext cx="200086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SVQQE</a:t>
            </a:r>
            <a:r>
              <a:rPr lang="en-US" sz="12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2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TIAK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T5F1)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3B5DF8B2-1FFA-4BDC-B84A-BD14FB743C67}"/>
              </a:ext>
            </a:extLst>
          </p:cNvPr>
          <p:cNvSpPr/>
          <p:nvPr/>
        </p:nvSpPr>
        <p:spPr>
          <a:xfrm>
            <a:off x="158944" y="2095040"/>
            <a:ext cx="187262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SVQQE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TIAK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T5F1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1BD7CA7-7520-423B-9C5F-CB74A150BB8B}"/>
              </a:ext>
            </a:extLst>
          </p:cNvPr>
          <p:cNvSpPr txBox="1"/>
          <p:nvPr/>
        </p:nvSpPr>
        <p:spPr>
          <a:xfrm>
            <a:off x="2087019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D71D594-85CF-4429-9010-D52F7189D917}"/>
              </a:ext>
            </a:extLst>
          </p:cNvPr>
          <p:cNvSpPr txBox="1"/>
          <p:nvPr/>
        </p:nvSpPr>
        <p:spPr>
          <a:xfrm>
            <a:off x="4240367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F1B1794-9FC0-443A-AF84-1A219B34EC6E}"/>
              </a:ext>
            </a:extLst>
          </p:cNvPr>
          <p:cNvSpPr txBox="1"/>
          <p:nvPr/>
        </p:nvSpPr>
        <p:spPr>
          <a:xfrm>
            <a:off x="0" y="0"/>
            <a:ext cx="6858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ry Figure S4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46C2377-667A-4F95-8147-808236BEF5E4}"/>
              </a:ext>
            </a:extLst>
          </p:cNvPr>
          <p:cNvSpPr txBox="1"/>
          <p:nvPr/>
        </p:nvSpPr>
        <p:spPr>
          <a:xfrm>
            <a:off x="158944" y="477818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SISVQQE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TIAK of the mitochondrial ATP synthase F(0) complex subunit B1 (AT5F1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203803B-2CDC-4E38-87BF-0A579E367264}"/>
              </a:ext>
            </a:extLst>
          </p:cNvPr>
          <p:cNvSpPr txBox="1"/>
          <p:nvPr/>
        </p:nvSpPr>
        <p:spPr>
          <a:xfrm>
            <a:off x="158944" y="3541497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SISVQQE</a:t>
            </a:r>
            <a:r>
              <a:rPr lang="en-US" sz="14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4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TIAK of the mitochondrial ATP synthase F(0) complex subunit B1 (AT5F1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C140D28-4CE6-4E14-BF8F-2079DE2A40C6}"/>
              </a:ext>
            </a:extLst>
          </p:cNvPr>
          <p:cNvSpPr txBox="1"/>
          <p:nvPr/>
        </p:nvSpPr>
        <p:spPr>
          <a:xfrm>
            <a:off x="2087019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457CF2CD-D620-4714-920E-2DFAD25241EA}"/>
              </a:ext>
            </a:extLst>
          </p:cNvPr>
          <p:cNvSpPr txBox="1"/>
          <p:nvPr/>
        </p:nvSpPr>
        <p:spPr>
          <a:xfrm>
            <a:off x="4240367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404027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Picture 35">
            <a:extLst>
              <a:ext uri="{FF2B5EF4-FFF2-40B4-BE49-F238E27FC236}">
                <a16:creationId xmlns:a16="http://schemas.microsoft.com/office/drawing/2014/main" id="{AC1E9777-AB96-4F0C-AF15-7635971053F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0739" y="4530218"/>
            <a:ext cx="1937939" cy="1774825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AE2A7EF4-C1F4-4911-BBBA-105776482FA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3425" y="4534764"/>
            <a:ext cx="1922404" cy="1774825"/>
          </a:xfrm>
          <a:prstGeom prst="rect">
            <a:avLst/>
          </a:prstGeom>
        </p:spPr>
      </p:pic>
      <p:sp>
        <p:nvSpPr>
          <p:cNvPr id="32" name="Rectangle 31">
            <a:extLst>
              <a:ext uri="{FF2B5EF4-FFF2-40B4-BE49-F238E27FC236}">
                <a16:creationId xmlns:a16="http://schemas.microsoft.com/office/drawing/2014/main" id="{A64EC56E-E64B-4148-AD03-27A30B6FF8E2}"/>
              </a:ext>
            </a:extLst>
          </p:cNvPr>
          <p:cNvSpPr/>
          <p:nvPr/>
        </p:nvSpPr>
        <p:spPr>
          <a:xfrm>
            <a:off x="163897" y="2083318"/>
            <a:ext cx="160332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YLD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PS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TPA)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0F8016E1-E8E7-4959-9DB9-3605769E55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60912" y="1452012"/>
            <a:ext cx="1647393" cy="1719018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6AB5E4B-CC9F-4809-929C-92E927B0B48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53694" y="1450621"/>
            <a:ext cx="1809493" cy="171901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620E6CA-6544-4A78-8703-E85801305045}"/>
              </a:ext>
            </a:extLst>
          </p:cNvPr>
          <p:cNvSpPr txBox="1"/>
          <p:nvPr/>
        </p:nvSpPr>
        <p:spPr>
          <a:xfrm>
            <a:off x="2087019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4856E2-E01E-477C-A66A-DD195E3A0F80}"/>
              </a:ext>
            </a:extLst>
          </p:cNvPr>
          <p:cNvSpPr txBox="1"/>
          <p:nvPr/>
        </p:nvSpPr>
        <p:spPr>
          <a:xfrm>
            <a:off x="4240367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950BDE2-237C-4BBB-A480-578063F7CE81}"/>
              </a:ext>
            </a:extLst>
          </p:cNvPr>
          <p:cNvSpPr txBox="1"/>
          <p:nvPr/>
        </p:nvSpPr>
        <p:spPr>
          <a:xfrm>
            <a:off x="158944" y="477818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GYLD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PSK of the mitochondrial ATP synthase subunit alpha (ATP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E322DE-3F42-480F-92C4-D2302369023B}"/>
              </a:ext>
            </a:extLst>
          </p:cNvPr>
          <p:cNvSpPr txBox="1"/>
          <p:nvPr/>
        </p:nvSpPr>
        <p:spPr>
          <a:xfrm>
            <a:off x="158944" y="3541497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GYLD</a:t>
            </a:r>
            <a:r>
              <a:rPr lang="en-US" sz="14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4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PSK of the mitochondrial ATP synthase subunit alpha (ATPA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5B8075-B9C1-4B64-8D8A-273F78E0F63D}"/>
              </a:ext>
            </a:extLst>
          </p:cNvPr>
          <p:cNvSpPr txBox="1"/>
          <p:nvPr/>
        </p:nvSpPr>
        <p:spPr>
          <a:xfrm>
            <a:off x="2087019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E36770-3BB5-4705-884C-C1A490BB94ED}"/>
              </a:ext>
            </a:extLst>
          </p:cNvPr>
          <p:cNvSpPr txBox="1"/>
          <p:nvPr/>
        </p:nvSpPr>
        <p:spPr>
          <a:xfrm>
            <a:off x="4240367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0A3A8889-2CAC-4294-ADCA-618E704312B6}"/>
              </a:ext>
            </a:extLst>
          </p:cNvPr>
          <p:cNvSpPr/>
          <p:nvPr/>
        </p:nvSpPr>
        <p:spPr>
          <a:xfrm>
            <a:off x="158944" y="5205612"/>
            <a:ext cx="173156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YLD</a:t>
            </a:r>
            <a:r>
              <a:rPr lang="en-US" sz="12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2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PS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TPA)</a:t>
            </a:r>
          </a:p>
        </p:txBody>
      </p:sp>
    </p:spTree>
    <p:extLst>
      <p:ext uri="{BB962C8B-B14F-4D97-AF65-F5344CB8AC3E}">
        <p14:creationId xmlns:p14="http://schemas.microsoft.com/office/powerpoint/2010/main" val="1547879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>
            <a:extLst>
              <a:ext uri="{FF2B5EF4-FFF2-40B4-BE49-F238E27FC236}">
                <a16:creationId xmlns:a16="http://schemas.microsoft.com/office/drawing/2014/main" id="{251D7892-472D-455F-B83D-6389FDC4052B}"/>
              </a:ext>
            </a:extLst>
          </p:cNvPr>
          <p:cNvSpPr/>
          <p:nvPr/>
        </p:nvSpPr>
        <p:spPr>
          <a:xfrm>
            <a:off x="85823" y="5233150"/>
            <a:ext cx="211147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QPPP</a:t>
            </a:r>
            <a:r>
              <a:rPr lang="en-US" sz="12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2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PVGPSH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NDUA7)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C301E3CD-3EBF-4EDF-909B-3DDB7CF9143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45637" y="4548344"/>
            <a:ext cx="1888258" cy="175669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1F55D326-B252-4ED8-B27C-9541398DA84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08692" y="4547395"/>
            <a:ext cx="1884388" cy="1756698"/>
          </a:xfrm>
          <a:prstGeom prst="rect">
            <a:avLst/>
          </a:prstGeom>
        </p:spPr>
      </p:pic>
      <p:sp>
        <p:nvSpPr>
          <p:cNvPr id="14" name="Rectangle 13">
            <a:extLst>
              <a:ext uri="{FF2B5EF4-FFF2-40B4-BE49-F238E27FC236}">
                <a16:creationId xmlns:a16="http://schemas.microsoft.com/office/drawing/2014/main" id="{CFAAA620-06B7-4459-9964-59EFC45A0592}"/>
              </a:ext>
            </a:extLst>
          </p:cNvPr>
          <p:cNvSpPr/>
          <p:nvPr/>
        </p:nvSpPr>
        <p:spPr>
          <a:xfrm>
            <a:off x="85823" y="2099285"/>
            <a:ext cx="198323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QPPP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PVGPSH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NDUA7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B80A02F5-C67D-4727-BF48-6ACCDAA835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89319" y="1560801"/>
            <a:ext cx="1664227" cy="157138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75800F9D-6310-45D2-B762-B85153649DD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57140" y="1563902"/>
            <a:ext cx="1660788" cy="156794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620E6CA-6544-4A78-8703-E85801305045}"/>
              </a:ext>
            </a:extLst>
          </p:cNvPr>
          <p:cNvSpPr txBox="1"/>
          <p:nvPr/>
        </p:nvSpPr>
        <p:spPr>
          <a:xfrm>
            <a:off x="2087019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4856E2-E01E-477C-A66A-DD195E3A0F80}"/>
              </a:ext>
            </a:extLst>
          </p:cNvPr>
          <p:cNvSpPr txBox="1"/>
          <p:nvPr/>
        </p:nvSpPr>
        <p:spPr>
          <a:xfrm>
            <a:off x="4240367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950BDE2-237C-4BBB-A480-578063F7CE81}"/>
              </a:ext>
            </a:extLst>
          </p:cNvPr>
          <p:cNvSpPr txBox="1"/>
          <p:nvPr/>
        </p:nvSpPr>
        <p:spPr>
          <a:xfrm>
            <a:off x="158944" y="477818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TQPPP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PVGPSHK of the NADH dehydrogenase [ubiquinone] 1 alpha subcomplex subunit 7 (NDUA7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E322DE-3F42-480F-92C4-D2302369023B}"/>
              </a:ext>
            </a:extLst>
          </p:cNvPr>
          <p:cNvSpPr txBox="1"/>
          <p:nvPr/>
        </p:nvSpPr>
        <p:spPr>
          <a:xfrm>
            <a:off x="158944" y="3541497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TQPPP</a:t>
            </a:r>
            <a:r>
              <a:rPr lang="en-US" sz="14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4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PVGPSHK of the NADH dehydrogenase [ubiquinone] 1 alpha subcomplex subunit 7 (NDUA7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5B8075-B9C1-4B64-8D8A-273F78E0F63D}"/>
              </a:ext>
            </a:extLst>
          </p:cNvPr>
          <p:cNvSpPr txBox="1"/>
          <p:nvPr/>
        </p:nvSpPr>
        <p:spPr>
          <a:xfrm>
            <a:off x="2087019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E36770-3BB5-4705-884C-C1A490BB94ED}"/>
              </a:ext>
            </a:extLst>
          </p:cNvPr>
          <p:cNvSpPr txBox="1"/>
          <p:nvPr/>
        </p:nvSpPr>
        <p:spPr>
          <a:xfrm>
            <a:off x="4240367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30119600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Rectangle 28">
            <a:extLst>
              <a:ext uri="{FF2B5EF4-FFF2-40B4-BE49-F238E27FC236}">
                <a16:creationId xmlns:a16="http://schemas.microsoft.com/office/drawing/2014/main" id="{23FD7FEE-3E5A-4DFB-BD54-B3640F623550}"/>
              </a:ext>
            </a:extLst>
          </p:cNvPr>
          <p:cNvSpPr/>
          <p:nvPr/>
        </p:nvSpPr>
        <p:spPr>
          <a:xfrm>
            <a:off x="106414" y="5203243"/>
            <a:ext cx="1997663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ADVG</a:t>
            </a:r>
            <a:r>
              <a:rPr lang="en-US" sz="12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2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SQR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NT1)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16734A63-0A11-4133-A56A-93EA61ACEEF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2673" y="4572000"/>
            <a:ext cx="1871768" cy="1744147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0FC534F2-758E-45EB-8D1C-5AF8316953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22298" y="4571929"/>
            <a:ext cx="1879503" cy="1740281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8DA5784C-0F6C-4B17-8040-8CB9BEB99C51}"/>
              </a:ext>
            </a:extLst>
          </p:cNvPr>
          <p:cNvSpPr/>
          <p:nvPr/>
        </p:nvSpPr>
        <p:spPr>
          <a:xfrm>
            <a:off x="85823" y="2118477"/>
            <a:ext cx="185339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AADVG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SSQR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NT1)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2110D0C3-9DD7-4413-A7CE-2F751856B77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52673" y="1421294"/>
            <a:ext cx="1963427" cy="1742731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AF619CF1-678E-4402-9161-AA1636931D9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13123" y="1407676"/>
            <a:ext cx="1952011" cy="1750342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4620E6CA-6544-4A78-8703-E85801305045}"/>
              </a:ext>
            </a:extLst>
          </p:cNvPr>
          <p:cNvSpPr txBox="1"/>
          <p:nvPr/>
        </p:nvSpPr>
        <p:spPr>
          <a:xfrm>
            <a:off x="2087019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4856E2-E01E-477C-A66A-DD195E3A0F80}"/>
              </a:ext>
            </a:extLst>
          </p:cNvPr>
          <p:cNvSpPr txBox="1"/>
          <p:nvPr/>
        </p:nvSpPr>
        <p:spPr>
          <a:xfrm>
            <a:off x="4240367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950BDE2-237C-4BBB-A480-578063F7CE81}"/>
              </a:ext>
            </a:extLst>
          </p:cNvPr>
          <p:cNvSpPr txBox="1"/>
          <p:nvPr/>
        </p:nvSpPr>
        <p:spPr>
          <a:xfrm>
            <a:off x="158944" y="477818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LAADVG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SQR of the ADP/ATP translocase 1 (ADT1/ANT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E322DE-3F42-480F-92C4-D2302369023B}"/>
              </a:ext>
            </a:extLst>
          </p:cNvPr>
          <p:cNvSpPr txBox="1"/>
          <p:nvPr/>
        </p:nvSpPr>
        <p:spPr>
          <a:xfrm>
            <a:off x="158944" y="3541497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LAADVG</a:t>
            </a:r>
            <a:r>
              <a:rPr lang="en-US" sz="1400" b="1" baseline="30000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400" b="1" dirty="0">
                <a:solidFill>
                  <a:srgbClr val="4E67C8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SQR of the ADP/ATP translocase 1 (ADT1/ANT1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5B8075-B9C1-4B64-8D8A-273F78E0F63D}"/>
              </a:ext>
            </a:extLst>
          </p:cNvPr>
          <p:cNvSpPr txBox="1"/>
          <p:nvPr/>
        </p:nvSpPr>
        <p:spPr>
          <a:xfrm>
            <a:off x="2087019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E36770-3BB5-4705-884C-C1A490BB94ED}"/>
              </a:ext>
            </a:extLst>
          </p:cNvPr>
          <p:cNvSpPr txBox="1"/>
          <p:nvPr/>
        </p:nvSpPr>
        <p:spPr>
          <a:xfrm>
            <a:off x="4240367" y="4184048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37244483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>
            <a:extLst>
              <a:ext uri="{FF2B5EF4-FFF2-40B4-BE49-F238E27FC236}">
                <a16:creationId xmlns:a16="http://schemas.microsoft.com/office/drawing/2014/main" id="{60B15921-C808-4D4F-A534-A27D86AF9656}"/>
              </a:ext>
            </a:extLst>
          </p:cNvPr>
          <p:cNvSpPr/>
          <p:nvPr/>
        </p:nvSpPr>
        <p:spPr>
          <a:xfrm>
            <a:off x="78849" y="7822644"/>
            <a:ext cx="1656031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GVLYVGS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YUB)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889770AD-0AB6-4274-B010-77A24A9ED9B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56170" y="7160605"/>
            <a:ext cx="1770991" cy="1708269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BC18C444-1AD2-4C21-9A47-22531FFA57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30670" y="7161245"/>
            <a:ext cx="1767301" cy="1704579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6D5D79F-E927-4E31-9EC6-98ECFDD2E43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79920" y="4429173"/>
            <a:ext cx="1738206" cy="1586156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D572EB1-4C42-4001-AC08-670643D382F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49729" y="4429172"/>
            <a:ext cx="1731295" cy="1582701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C0933311-850D-4481-AA2B-3ABBCAD2C622}"/>
              </a:ext>
            </a:extLst>
          </p:cNvPr>
          <p:cNvSpPr/>
          <p:nvPr/>
        </p:nvSpPr>
        <p:spPr>
          <a:xfrm>
            <a:off x="158944" y="4986131"/>
            <a:ext cx="167706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GVTEAAE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SYUB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9FB6A1C-34BD-4398-B0E8-C4749B81E3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65569" y="1464379"/>
            <a:ext cx="1812533" cy="168814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AAEDECD-A940-40B5-9B04-059238A1EBE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344138" y="1462893"/>
            <a:ext cx="1805426" cy="1688144"/>
          </a:xfrm>
          <a:prstGeom prst="rect">
            <a:avLst/>
          </a:prstGeom>
        </p:spPr>
      </p:pic>
      <p:sp>
        <p:nvSpPr>
          <p:cNvPr id="16" name="Rectangle 15">
            <a:extLst>
              <a:ext uri="{FF2B5EF4-FFF2-40B4-BE49-F238E27FC236}">
                <a16:creationId xmlns:a16="http://schemas.microsoft.com/office/drawing/2014/main" id="{23FF736D-331C-4DA0-BC7B-BA3D2BB2A023}"/>
              </a:ext>
            </a:extLst>
          </p:cNvPr>
          <p:cNvSpPr/>
          <p:nvPr/>
        </p:nvSpPr>
        <p:spPr>
          <a:xfrm>
            <a:off x="158944" y="2076132"/>
            <a:ext cx="186762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V</a:t>
            </a:r>
            <a:r>
              <a:rPr lang="en-US" sz="12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r>
              <a:rPr lang="en-US" sz="12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CTGHEYAAK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KCC2B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20E6CA-6544-4A78-8703-E85801305045}"/>
              </a:ext>
            </a:extLst>
          </p:cNvPr>
          <p:cNvSpPr txBox="1"/>
          <p:nvPr/>
        </p:nvSpPr>
        <p:spPr>
          <a:xfrm>
            <a:off x="2087019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94856E2-E01E-477C-A66A-DD195E3A0F80}"/>
              </a:ext>
            </a:extLst>
          </p:cNvPr>
          <p:cNvSpPr txBox="1"/>
          <p:nvPr/>
        </p:nvSpPr>
        <p:spPr>
          <a:xfrm>
            <a:off x="4240367" y="1078820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950BDE2-237C-4BBB-A480-578063F7CE81}"/>
              </a:ext>
            </a:extLst>
          </p:cNvPr>
          <p:cNvSpPr txBox="1"/>
          <p:nvPr/>
        </p:nvSpPr>
        <p:spPr>
          <a:xfrm>
            <a:off x="158944" y="477818"/>
            <a:ext cx="63843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CV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CTGHEYAAK of the calcium/calmodulin-dependent protein kinase type II subunit beta (KCC2B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9E322DE-3F42-480F-92C4-D2302369023B}"/>
              </a:ext>
            </a:extLst>
          </p:cNvPr>
          <p:cNvSpPr txBox="1"/>
          <p:nvPr/>
        </p:nvSpPr>
        <p:spPr>
          <a:xfrm>
            <a:off x="158944" y="3541497"/>
            <a:ext cx="6384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T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GVTEAAEK of the beta-synuclein (SYU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5B8075-B9C1-4B64-8D8A-273F78E0F63D}"/>
              </a:ext>
            </a:extLst>
          </p:cNvPr>
          <p:cNvSpPr txBox="1"/>
          <p:nvPr/>
        </p:nvSpPr>
        <p:spPr>
          <a:xfrm>
            <a:off x="2087019" y="3910917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1E36770-3BB5-4705-884C-C1A490BB94ED}"/>
              </a:ext>
            </a:extLst>
          </p:cNvPr>
          <p:cNvSpPr txBox="1"/>
          <p:nvPr/>
        </p:nvSpPr>
        <p:spPr>
          <a:xfrm>
            <a:off x="4240367" y="3910917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4DC9056-BF8A-4F2B-8B7A-B93F20685927}"/>
              </a:ext>
            </a:extLst>
          </p:cNvPr>
          <p:cNvSpPr txBox="1"/>
          <p:nvPr/>
        </p:nvSpPr>
        <p:spPr>
          <a:xfrm>
            <a:off x="158944" y="6384426"/>
            <a:ext cx="63843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XIC MS2 of T</a:t>
            </a:r>
            <a:r>
              <a:rPr lang="en-US" sz="1400" b="1" baseline="30000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r>
              <a:rPr lang="en-US" sz="1400" b="1" dirty="0">
                <a:solidFill>
                  <a:srgbClr val="D62A0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GVLYVGSK of the beta-synuclein (SYUB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777B6B3-4ED6-4E0E-A015-4F3032C7DA68}"/>
              </a:ext>
            </a:extLst>
          </p:cNvPr>
          <p:cNvSpPr txBox="1"/>
          <p:nvPr/>
        </p:nvSpPr>
        <p:spPr>
          <a:xfrm>
            <a:off x="2087019" y="6753846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IRT5-KO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EC14DD8-1B41-442B-9DA4-FF03C102C8BE}"/>
              </a:ext>
            </a:extLst>
          </p:cNvPr>
          <p:cNvSpPr txBox="1"/>
          <p:nvPr/>
        </p:nvSpPr>
        <p:spPr>
          <a:xfrm>
            <a:off x="4240367" y="6753846"/>
            <a:ext cx="2141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10610548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Rectangle 117">
            <a:extLst>
              <a:ext uri="{FF2B5EF4-FFF2-40B4-BE49-F238E27FC236}">
                <a16:creationId xmlns:a16="http://schemas.microsoft.com/office/drawing/2014/main" id="{4EA7DD3C-F081-4E0F-88C7-A8BDB19A79A2}"/>
              </a:ext>
            </a:extLst>
          </p:cNvPr>
          <p:cNvSpPr/>
          <p:nvPr/>
        </p:nvSpPr>
        <p:spPr>
          <a:xfrm>
            <a:off x="368134" y="261165"/>
            <a:ext cx="6068291" cy="55461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 Additional SIRT5-targeted proteins involved in Parkinson’s disease.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 Extracted ion chromatograms of SISVQQE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TIAK (m/z 773.90, z = 2+) and SISVQQE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3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TIAK (m/z 780.91, z = 2+) of the mitochondrial ATP synthase F(0) complex subunit B1 (AT5F1), GYLD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PSK (m/z 618.31, z = 2+) and GYLD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98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EPSK (m/z 625.32, z = 2+) of the mitochondrial ATP synthase subunit alpha (ATPA), TQPPP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PVGPSHK (m/z 523.62, z = 3+) and TQPPP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PVGPSHK (m/z 528.29, z = 3+) of the NADH dehydrogenase [ubiquinone] 1 alpha subcomplex subunit 7 (NDUA7), LAADVG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SQR (m/z 637.82, z = 2+) and LAADVG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47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suc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GSSQR (m/z 644.83, z = 2+) of the ADP/ATP translocase 1 (ADT1/ANT1), CV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CTGHEYAAK (m/z 541.58, z = 3+) of the calcium/calmodulin-dependent protein kinase type II subunit beta (KCC2B), and T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3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QGVTEAAEK (m/z 624.31, z = 2+) and T</a:t>
            </a:r>
            <a:r>
              <a:rPr lang="en-US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4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Kma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EGVLYVGSK (m/z 633.83, z = 2+) of the beta-synuclein (SYUB) in a SIRT5-KO and WT replicate. </a:t>
            </a:r>
          </a:p>
        </p:txBody>
      </p:sp>
    </p:spTree>
    <p:extLst>
      <p:ext uri="{BB962C8B-B14F-4D97-AF65-F5344CB8AC3E}">
        <p14:creationId xmlns:p14="http://schemas.microsoft.com/office/powerpoint/2010/main" val="1278306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493</Words>
  <Application>Microsoft Office PowerPoint</Application>
  <PresentationFormat>Letter Paper (8.5x11 in)</PresentationFormat>
  <Paragraphs>62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anna Bons</dc:creator>
  <cp:lastModifiedBy>Joanna Bons</cp:lastModifiedBy>
  <cp:revision>11</cp:revision>
  <dcterms:created xsi:type="dcterms:W3CDTF">2022-06-01T02:05:19Z</dcterms:created>
  <dcterms:modified xsi:type="dcterms:W3CDTF">2022-06-23T22:42:42Z</dcterms:modified>
</cp:coreProperties>
</file>